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lexey Danilov" initials="AD" lastIdx="18" clrIdx="0"/>
  <p:cmAuthor id="1" name="Danilov" initials="D" lastIdx="17" clrIdx="1"/>
  <p:cmAuthor id="2" name="Taylor" initials="T" lastIdx="4" clrIdx="2">
    <p:extLst>
      <p:ext uri="{19B8F6BF-5375-455C-9EA6-DF929625EA0E}">
        <p15:presenceInfo xmlns:p15="http://schemas.microsoft.com/office/powerpoint/2012/main" userId="Tayl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3623" autoAdjust="0"/>
  </p:normalViewPr>
  <p:slideViewPr>
    <p:cSldViewPr snapToGrid="0" snapToObjects="1">
      <p:cViewPr varScale="1">
        <p:scale>
          <a:sx n="63" d="100"/>
          <a:sy n="63" d="100"/>
        </p:scale>
        <p:origin x="2458" y="5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1CA6D1-FD7D-4924-94D9-306140B186F1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C224BC-563E-452B-A1DC-43DDDB51480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3745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FFA6E-8719-434E-A383-AE8BD4435E17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572F8-F2DE-B24A-B37D-B1447222275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2411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FFA6E-8719-434E-A383-AE8BD4435E17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572F8-F2DE-B24A-B37D-B1447222275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786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FFA6E-8719-434E-A383-AE8BD4435E17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572F8-F2DE-B24A-B37D-B1447222275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2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FFA6E-8719-434E-A383-AE8BD4435E17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572F8-F2DE-B24A-B37D-B1447222275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387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FFA6E-8719-434E-A383-AE8BD4435E17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572F8-F2DE-B24A-B37D-B1447222275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7144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FFA6E-8719-434E-A383-AE8BD4435E17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572F8-F2DE-B24A-B37D-B1447222275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6839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FFA6E-8719-434E-A383-AE8BD4435E17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572F8-F2DE-B24A-B37D-B1447222275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4609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FFA6E-8719-434E-A383-AE8BD4435E17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572F8-F2DE-B24A-B37D-B1447222275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69589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FFA6E-8719-434E-A383-AE8BD4435E17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572F8-F2DE-B24A-B37D-B1447222275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876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FFA6E-8719-434E-A383-AE8BD4435E17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572F8-F2DE-B24A-B37D-B1447222275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9686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FFA6E-8719-434E-A383-AE8BD4435E17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5572F8-F2DE-B24A-B37D-B1447222275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4247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FFFA6E-8719-434E-A383-AE8BD4435E17}" type="datetimeFigureOut">
              <a:rPr lang="en-US" smtClean="0"/>
              <a:pPr/>
              <a:t>11/1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5572F8-F2DE-B24A-B37D-B1447222275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044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-18676" y="-1"/>
            <a:ext cx="2346690" cy="519545"/>
          </a:xfrm>
        </p:spPr>
        <p:txBody>
          <a:bodyPr>
            <a:normAutofit/>
          </a:bodyPr>
          <a:lstStyle/>
          <a:p>
            <a:r>
              <a:rPr lang="en-US" sz="1600" b="1" u="sng" dirty="0" smtClean="0"/>
              <a:t>Figure </a:t>
            </a:r>
            <a:r>
              <a:rPr lang="en-US" sz="1600" b="1" u="sng" dirty="0" smtClean="0"/>
              <a:t>S2</a:t>
            </a:r>
            <a:endParaRPr lang="en-US" sz="1600" b="1" u="sng" dirty="0"/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60618" y="3223574"/>
            <a:ext cx="3820649" cy="1036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5" name="TextBox 14"/>
          <p:cNvSpPr txBox="1"/>
          <p:nvPr/>
        </p:nvSpPr>
        <p:spPr>
          <a:xfrm>
            <a:off x="666470" y="3950215"/>
            <a:ext cx="53514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/>
              <a:t>GAPDH</a:t>
            </a:r>
            <a:endParaRPr lang="en-US" sz="9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140233" y="3206173"/>
            <a:ext cx="108342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/>
              <a:t>p-PRAS40 (Thr246)</a:t>
            </a:r>
            <a:endParaRPr lang="en-US" sz="9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323064" y="3437899"/>
            <a:ext cx="89271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/>
              <a:t>p-Bad (Ser112)</a:t>
            </a:r>
            <a:endParaRPr lang="en-US" sz="9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317224" y="3668101"/>
            <a:ext cx="8967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/>
              <a:t>p-ASK1 (Ser83)</a:t>
            </a:r>
            <a:endParaRPr lang="en-US" sz="9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56281" y="2799216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B</a:t>
            </a:r>
            <a:endParaRPr lang="en-US" sz="14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56281" y="751460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A</a:t>
            </a:r>
            <a:endParaRPr lang="en-US" sz="14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100946" y="1220456"/>
            <a:ext cx="11160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/>
              <a:t>p-</a:t>
            </a:r>
            <a:r>
              <a:rPr lang="el-GR" sz="900" b="1" dirty="0" smtClean="0"/>
              <a:t>β</a:t>
            </a:r>
            <a:r>
              <a:rPr lang="en-US" sz="900" b="1" dirty="0" smtClean="0"/>
              <a:t>-</a:t>
            </a:r>
            <a:r>
              <a:rPr lang="en-US" sz="900" b="1" dirty="0" err="1" smtClean="0"/>
              <a:t>Catenin</a:t>
            </a:r>
            <a:r>
              <a:rPr lang="en-US" sz="900" b="1" dirty="0" smtClean="0"/>
              <a:t> (Ser45)</a:t>
            </a:r>
            <a:endParaRPr lang="en-US" sz="9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777805" y="1894212"/>
            <a:ext cx="4427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/>
              <a:t>PARP</a:t>
            </a:r>
            <a:endParaRPr lang="en-US" sz="9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679822" y="2351438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/>
              <a:t>GAPDH</a:t>
            </a:r>
            <a:endParaRPr lang="en-US" sz="9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197600" y="1492016"/>
            <a:ext cx="101662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/>
              <a:t>p-GSK3</a:t>
            </a:r>
            <a:r>
              <a:rPr lang="el-GR" sz="900" b="1" dirty="0" smtClean="0"/>
              <a:t>β</a:t>
            </a:r>
            <a:r>
              <a:rPr lang="en-US" sz="900" b="1" dirty="0" smtClean="0"/>
              <a:t> (Tyr216)</a:t>
            </a:r>
            <a:endParaRPr lang="en-US" sz="900" b="1" dirty="0"/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161921" y="1196704"/>
            <a:ext cx="3156964" cy="15119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2" name="TextBox 31"/>
          <p:cNvSpPr txBox="1"/>
          <p:nvPr/>
        </p:nvSpPr>
        <p:spPr>
          <a:xfrm>
            <a:off x="1179735" y="1043492"/>
            <a:ext cx="31117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 0         0.5       1       1.5       0       0.5       1       1.5       0        0.5       1        1.5</a:t>
            </a:r>
            <a:endParaRPr lang="en-US" sz="800" dirty="0"/>
          </a:p>
        </p:txBody>
      </p:sp>
      <p:sp>
        <p:nvSpPr>
          <p:cNvPr id="33" name="TextBox 32"/>
          <p:cNvSpPr txBox="1"/>
          <p:nvPr/>
        </p:nvSpPr>
        <p:spPr>
          <a:xfrm>
            <a:off x="4135692" y="1018653"/>
            <a:ext cx="9428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    P1446A, µM</a:t>
            </a:r>
            <a:endParaRPr lang="en-US" sz="1000" dirty="0"/>
          </a:p>
        </p:txBody>
      </p:sp>
      <p:cxnSp>
        <p:nvCxnSpPr>
          <p:cNvPr id="38" name="Straight Connector 37"/>
          <p:cNvCxnSpPr/>
          <p:nvPr/>
        </p:nvCxnSpPr>
        <p:spPr>
          <a:xfrm>
            <a:off x="3312123" y="1066923"/>
            <a:ext cx="8148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3563258" y="880098"/>
            <a:ext cx="324079" cy="253889"/>
          </a:xfrm>
          <a:prstGeom prst="rect">
            <a:avLst/>
          </a:prstGeom>
          <a:noFill/>
        </p:spPr>
        <p:txBody>
          <a:bodyPr wrap="none" lIns="91416" tIns="45707" rIns="91416" bIns="45707" rtlCol="0">
            <a:spAutoFit/>
          </a:bodyPr>
          <a:lstStyle/>
          <a:p>
            <a:r>
              <a:rPr lang="en-US" sz="1050" dirty="0" smtClean="0"/>
              <a:t>6h</a:t>
            </a:r>
            <a:endParaRPr lang="en-US" sz="1050" dirty="0"/>
          </a:p>
        </p:txBody>
      </p:sp>
      <p:cxnSp>
        <p:nvCxnSpPr>
          <p:cNvPr id="44" name="Straight Connector 43"/>
          <p:cNvCxnSpPr/>
          <p:nvPr/>
        </p:nvCxnSpPr>
        <p:spPr>
          <a:xfrm>
            <a:off x="2328014" y="1064935"/>
            <a:ext cx="8148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2579149" y="878110"/>
            <a:ext cx="324079" cy="253889"/>
          </a:xfrm>
          <a:prstGeom prst="rect">
            <a:avLst/>
          </a:prstGeom>
          <a:noFill/>
        </p:spPr>
        <p:txBody>
          <a:bodyPr wrap="none" lIns="91416" tIns="45707" rIns="91416" bIns="45707" rtlCol="0">
            <a:spAutoFit/>
          </a:bodyPr>
          <a:lstStyle/>
          <a:p>
            <a:r>
              <a:rPr lang="en-US" sz="1050" dirty="0" smtClean="0"/>
              <a:t>4h</a:t>
            </a:r>
            <a:endParaRPr lang="en-US" sz="1050" dirty="0"/>
          </a:p>
        </p:txBody>
      </p:sp>
      <p:cxnSp>
        <p:nvCxnSpPr>
          <p:cNvPr id="46" name="Straight Connector 45"/>
          <p:cNvCxnSpPr/>
          <p:nvPr/>
        </p:nvCxnSpPr>
        <p:spPr>
          <a:xfrm>
            <a:off x="1309799" y="1067204"/>
            <a:ext cx="8148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1589509" y="880379"/>
            <a:ext cx="324079" cy="253889"/>
          </a:xfrm>
          <a:prstGeom prst="rect">
            <a:avLst/>
          </a:prstGeom>
          <a:noFill/>
        </p:spPr>
        <p:txBody>
          <a:bodyPr wrap="none" lIns="91416" tIns="45707" rIns="91416" bIns="45707" rtlCol="0">
            <a:spAutoFit/>
          </a:bodyPr>
          <a:lstStyle/>
          <a:p>
            <a:r>
              <a:rPr lang="en-US" sz="1050" dirty="0" smtClean="0"/>
              <a:t>2h</a:t>
            </a:r>
            <a:endParaRPr lang="en-US" sz="1050" dirty="0"/>
          </a:p>
        </p:txBody>
      </p:sp>
      <p:sp>
        <p:nvSpPr>
          <p:cNvPr id="30" name="TextBox 29"/>
          <p:cNvSpPr txBox="1"/>
          <p:nvPr/>
        </p:nvSpPr>
        <p:spPr>
          <a:xfrm>
            <a:off x="1201520" y="3080163"/>
            <a:ext cx="37625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/>
              <a:t> 0           0.5        1         1.5          0          0.5         1          1.5         0          0.5         1           1.5</a:t>
            </a:r>
            <a:endParaRPr lang="en-US" sz="800" dirty="0"/>
          </a:p>
        </p:txBody>
      </p:sp>
      <p:sp>
        <p:nvSpPr>
          <p:cNvPr id="31" name="TextBox 30"/>
          <p:cNvSpPr txBox="1"/>
          <p:nvPr/>
        </p:nvSpPr>
        <p:spPr>
          <a:xfrm>
            <a:off x="4816295" y="3032299"/>
            <a:ext cx="9428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    P1446A, µM</a:t>
            </a:r>
            <a:endParaRPr lang="en-US" sz="1000" dirty="0"/>
          </a:p>
        </p:txBody>
      </p:sp>
      <p:cxnSp>
        <p:nvCxnSpPr>
          <p:cNvPr id="36" name="Straight Connector 35"/>
          <p:cNvCxnSpPr/>
          <p:nvPr/>
        </p:nvCxnSpPr>
        <p:spPr>
          <a:xfrm flipV="1">
            <a:off x="3760941" y="3101606"/>
            <a:ext cx="1026779" cy="226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4094610" y="2916769"/>
            <a:ext cx="324079" cy="253889"/>
          </a:xfrm>
          <a:prstGeom prst="rect">
            <a:avLst/>
          </a:prstGeom>
          <a:noFill/>
        </p:spPr>
        <p:txBody>
          <a:bodyPr wrap="none" lIns="91416" tIns="45707" rIns="91416" bIns="45707" rtlCol="0">
            <a:spAutoFit/>
          </a:bodyPr>
          <a:lstStyle/>
          <a:p>
            <a:r>
              <a:rPr lang="en-US" sz="1050" dirty="0" smtClean="0"/>
              <a:t>6h</a:t>
            </a:r>
            <a:endParaRPr lang="en-US" sz="1050" dirty="0"/>
          </a:p>
        </p:txBody>
      </p:sp>
      <p:cxnSp>
        <p:nvCxnSpPr>
          <p:cNvPr id="50" name="Straight Connector 49"/>
          <p:cNvCxnSpPr/>
          <p:nvPr/>
        </p:nvCxnSpPr>
        <p:spPr>
          <a:xfrm flipV="1">
            <a:off x="2524458" y="3102417"/>
            <a:ext cx="1026779" cy="226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2858127" y="2917580"/>
            <a:ext cx="323609" cy="253889"/>
          </a:xfrm>
          <a:prstGeom prst="rect">
            <a:avLst/>
          </a:prstGeom>
          <a:noFill/>
        </p:spPr>
        <p:txBody>
          <a:bodyPr wrap="none" lIns="91416" tIns="45707" rIns="91416" bIns="45707" rtlCol="0">
            <a:spAutoFit/>
          </a:bodyPr>
          <a:lstStyle/>
          <a:p>
            <a:r>
              <a:rPr lang="en-US" sz="1050" dirty="0"/>
              <a:t>4</a:t>
            </a:r>
            <a:r>
              <a:rPr lang="en-US" sz="1050" dirty="0" smtClean="0"/>
              <a:t>h</a:t>
            </a:r>
            <a:endParaRPr lang="en-US" sz="1050" dirty="0"/>
          </a:p>
        </p:txBody>
      </p:sp>
      <p:cxnSp>
        <p:nvCxnSpPr>
          <p:cNvPr id="52" name="Straight Connector 51"/>
          <p:cNvCxnSpPr/>
          <p:nvPr/>
        </p:nvCxnSpPr>
        <p:spPr>
          <a:xfrm flipV="1">
            <a:off x="1298146" y="3103201"/>
            <a:ext cx="1026779" cy="226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1669915" y="2918364"/>
            <a:ext cx="323609" cy="253889"/>
          </a:xfrm>
          <a:prstGeom prst="rect">
            <a:avLst/>
          </a:prstGeom>
          <a:noFill/>
        </p:spPr>
        <p:txBody>
          <a:bodyPr wrap="none" lIns="91416" tIns="45707" rIns="91416" bIns="45707" rtlCol="0">
            <a:spAutoFit/>
          </a:bodyPr>
          <a:lstStyle/>
          <a:p>
            <a:r>
              <a:rPr lang="en-US" sz="1050" dirty="0"/>
              <a:t>2</a:t>
            </a:r>
            <a:r>
              <a:rPr lang="en-US" sz="1050" dirty="0" smtClean="0"/>
              <a:t>h</a:t>
            </a:r>
            <a:endParaRPr lang="en-US" sz="105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392</TotalTime>
  <Words>70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Figure S2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1446 Figures</dc:title>
  <dc:creator>Cody Paiva</dc:creator>
  <cp:lastModifiedBy>Alexey Danilov</cp:lastModifiedBy>
  <cp:revision>230</cp:revision>
  <dcterms:created xsi:type="dcterms:W3CDTF">2014-03-18T14:32:49Z</dcterms:created>
  <dcterms:modified xsi:type="dcterms:W3CDTF">2015-11-11T21:36:05Z</dcterms:modified>
</cp:coreProperties>
</file>